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23"/>
    <p:restoredTop sz="94668"/>
  </p:normalViewPr>
  <p:slideViewPr>
    <p:cSldViewPr snapToGrid="0" snapToObjects="1">
      <p:cViewPr varScale="1">
        <p:scale>
          <a:sx n="126" d="100"/>
          <a:sy n="126" d="100"/>
        </p:scale>
        <p:origin x="23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alvatoreesposito/GoogleDrive/arbor/writing/material/general_resul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NP_CALLING_DATA!$F$2</c:f>
              <c:strCache>
                <c:ptCount val="1"/>
                <c:pt idx="0">
                  <c:v>LOW</c:v>
                </c:pt>
              </c:strCache>
            </c:strRef>
          </c:tx>
          <c:spPr>
            <a:solidFill>
              <a:srgbClr val="3D69B9"/>
            </a:solidFill>
            <a:ln>
              <a:noFill/>
            </a:ln>
            <a:effectLst/>
          </c:spPr>
          <c:invertIfNegative val="0"/>
          <c:val>
            <c:numRef>
              <c:f>SNP_CALLING_DATA!$F$3:$F$50</c:f>
              <c:numCache>
                <c:formatCode>General</c:formatCode>
                <c:ptCount val="48"/>
                <c:pt idx="0">
                  <c:v>78194</c:v>
                </c:pt>
                <c:pt idx="1">
                  <c:v>92658</c:v>
                </c:pt>
                <c:pt idx="2">
                  <c:v>106784</c:v>
                </c:pt>
                <c:pt idx="3">
                  <c:v>84581</c:v>
                </c:pt>
                <c:pt idx="4">
                  <c:v>83451</c:v>
                </c:pt>
                <c:pt idx="5">
                  <c:v>90554</c:v>
                </c:pt>
                <c:pt idx="6">
                  <c:v>90788</c:v>
                </c:pt>
                <c:pt idx="7">
                  <c:v>98779</c:v>
                </c:pt>
                <c:pt idx="8">
                  <c:v>110117</c:v>
                </c:pt>
                <c:pt idx="9">
                  <c:v>91842</c:v>
                </c:pt>
                <c:pt idx="10">
                  <c:v>74579</c:v>
                </c:pt>
                <c:pt idx="11">
                  <c:v>97151</c:v>
                </c:pt>
                <c:pt idx="12">
                  <c:v>81130</c:v>
                </c:pt>
                <c:pt idx="13">
                  <c:v>94551</c:v>
                </c:pt>
                <c:pt idx="14">
                  <c:v>93014</c:v>
                </c:pt>
                <c:pt idx="15">
                  <c:v>102717</c:v>
                </c:pt>
                <c:pt idx="16">
                  <c:v>66703</c:v>
                </c:pt>
                <c:pt idx="17">
                  <c:v>92582</c:v>
                </c:pt>
                <c:pt idx="18">
                  <c:v>106278</c:v>
                </c:pt>
                <c:pt idx="19">
                  <c:v>68325</c:v>
                </c:pt>
                <c:pt idx="20">
                  <c:v>63618</c:v>
                </c:pt>
                <c:pt idx="21">
                  <c:v>81244</c:v>
                </c:pt>
                <c:pt idx="22">
                  <c:v>101729</c:v>
                </c:pt>
                <c:pt idx="23">
                  <c:v>97490</c:v>
                </c:pt>
                <c:pt idx="24">
                  <c:v>98715</c:v>
                </c:pt>
                <c:pt idx="25">
                  <c:v>102204</c:v>
                </c:pt>
                <c:pt idx="26">
                  <c:v>82044</c:v>
                </c:pt>
                <c:pt idx="27">
                  <c:v>94571</c:v>
                </c:pt>
                <c:pt idx="28">
                  <c:v>88186</c:v>
                </c:pt>
                <c:pt idx="29">
                  <c:v>82797</c:v>
                </c:pt>
                <c:pt idx="30">
                  <c:v>107909</c:v>
                </c:pt>
                <c:pt idx="31">
                  <c:v>76221</c:v>
                </c:pt>
                <c:pt idx="32">
                  <c:v>154394</c:v>
                </c:pt>
                <c:pt idx="33">
                  <c:v>142102</c:v>
                </c:pt>
                <c:pt idx="34">
                  <c:v>147445</c:v>
                </c:pt>
                <c:pt idx="35">
                  <c:v>136852</c:v>
                </c:pt>
                <c:pt idx="36">
                  <c:v>156449</c:v>
                </c:pt>
                <c:pt idx="37">
                  <c:v>160925</c:v>
                </c:pt>
                <c:pt idx="38">
                  <c:v>143185</c:v>
                </c:pt>
                <c:pt idx="39">
                  <c:v>118027</c:v>
                </c:pt>
                <c:pt idx="40">
                  <c:v>143324</c:v>
                </c:pt>
                <c:pt idx="41">
                  <c:v>152145</c:v>
                </c:pt>
                <c:pt idx="42">
                  <c:v>144551</c:v>
                </c:pt>
                <c:pt idx="43">
                  <c:v>150069</c:v>
                </c:pt>
                <c:pt idx="44">
                  <c:v>136385</c:v>
                </c:pt>
                <c:pt idx="45">
                  <c:v>134885</c:v>
                </c:pt>
                <c:pt idx="46">
                  <c:v>148623</c:v>
                </c:pt>
                <c:pt idx="47">
                  <c:v>1277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35-5946-970B-C2AA61B9C260}"/>
            </c:ext>
          </c:extLst>
        </c:ser>
        <c:ser>
          <c:idx val="1"/>
          <c:order val="1"/>
          <c:tx>
            <c:strRef>
              <c:f>SNP_CALLING_DATA!$G$2</c:f>
              <c:strCache>
                <c:ptCount val="1"/>
                <c:pt idx="0">
                  <c:v>MODERATE</c:v>
                </c:pt>
              </c:strCache>
            </c:strRef>
          </c:tx>
          <c:spPr>
            <a:solidFill>
              <a:srgbClr val="C60003"/>
            </a:solidFill>
            <a:ln>
              <a:noFill/>
            </a:ln>
            <a:effectLst/>
          </c:spPr>
          <c:invertIfNegative val="0"/>
          <c:val>
            <c:numRef>
              <c:f>SNP_CALLING_DATA!$G$3:$G$50</c:f>
              <c:numCache>
                <c:formatCode>General</c:formatCode>
                <c:ptCount val="48"/>
                <c:pt idx="0">
                  <c:v>94517</c:v>
                </c:pt>
                <c:pt idx="1">
                  <c:v>105795</c:v>
                </c:pt>
                <c:pt idx="2">
                  <c:v>120799</c:v>
                </c:pt>
                <c:pt idx="3">
                  <c:v>97401</c:v>
                </c:pt>
                <c:pt idx="4">
                  <c:v>100290</c:v>
                </c:pt>
                <c:pt idx="5">
                  <c:v>107797</c:v>
                </c:pt>
                <c:pt idx="6">
                  <c:v>103485</c:v>
                </c:pt>
                <c:pt idx="7">
                  <c:v>117293</c:v>
                </c:pt>
                <c:pt idx="8">
                  <c:v>125204</c:v>
                </c:pt>
                <c:pt idx="9">
                  <c:v>106500</c:v>
                </c:pt>
                <c:pt idx="10">
                  <c:v>90208</c:v>
                </c:pt>
                <c:pt idx="11">
                  <c:v>115288</c:v>
                </c:pt>
                <c:pt idx="12">
                  <c:v>97742</c:v>
                </c:pt>
                <c:pt idx="13">
                  <c:v>111064</c:v>
                </c:pt>
                <c:pt idx="14">
                  <c:v>111404</c:v>
                </c:pt>
                <c:pt idx="15">
                  <c:v>117736</c:v>
                </c:pt>
                <c:pt idx="16">
                  <c:v>82944</c:v>
                </c:pt>
                <c:pt idx="17">
                  <c:v>108490</c:v>
                </c:pt>
                <c:pt idx="18">
                  <c:v>122566</c:v>
                </c:pt>
                <c:pt idx="19">
                  <c:v>84612</c:v>
                </c:pt>
                <c:pt idx="20">
                  <c:v>76753</c:v>
                </c:pt>
                <c:pt idx="21">
                  <c:v>97510</c:v>
                </c:pt>
                <c:pt idx="22">
                  <c:v>117367</c:v>
                </c:pt>
                <c:pt idx="23">
                  <c:v>112195</c:v>
                </c:pt>
                <c:pt idx="24">
                  <c:v>115972</c:v>
                </c:pt>
                <c:pt idx="25">
                  <c:v>123914</c:v>
                </c:pt>
                <c:pt idx="26">
                  <c:v>99494</c:v>
                </c:pt>
                <c:pt idx="27">
                  <c:v>113838</c:v>
                </c:pt>
                <c:pt idx="28">
                  <c:v>106656</c:v>
                </c:pt>
                <c:pt idx="29">
                  <c:v>100144</c:v>
                </c:pt>
                <c:pt idx="30">
                  <c:v>125853</c:v>
                </c:pt>
                <c:pt idx="31">
                  <c:v>92929</c:v>
                </c:pt>
                <c:pt idx="32">
                  <c:v>157723</c:v>
                </c:pt>
                <c:pt idx="33">
                  <c:v>144938</c:v>
                </c:pt>
                <c:pt idx="34">
                  <c:v>147445</c:v>
                </c:pt>
                <c:pt idx="35">
                  <c:v>136852</c:v>
                </c:pt>
                <c:pt idx="36">
                  <c:v>156449</c:v>
                </c:pt>
                <c:pt idx="37">
                  <c:v>160925</c:v>
                </c:pt>
                <c:pt idx="38">
                  <c:v>143185</c:v>
                </c:pt>
                <c:pt idx="39">
                  <c:v>118027</c:v>
                </c:pt>
                <c:pt idx="40">
                  <c:v>147099</c:v>
                </c:pt>
                <c:pt idx="41">
                  <c:v>152145</c:v>
                </c:pt>
                <c:pt idx="42">
                  <c:v>148597</c:v>
                </c:pt>
                <c:pt idx="43">
                  <c:v>153954</c:v>
                </c:pt>
                <c:pt idx="44">
                  <c:v>144058</c:v>
                </c:pt>
                <c:pt idx="45">
                  <c:v>143045</c:v>
                </c:pt>
                <c:pt idx="46">
                  <c:v>151419</c:v>
                </c:pt>
                <c:pt idx="47">
                  <c:v>1371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235-5946-970B-C2AA61B9C260}"/>
            </c:ext>
          </c:extLst>
        </c:ser>
        <c:ser>
          <c:idx val="2"/>
          <c:order val="2"/>
          <c:tx>
            <c:strRef>
              <c:f>SNP_CALLING_DATA!$H$2</c:f>
              <c:strCache>
                <c:ptCount val="1"/>
                <c:pt idx="0">
                  <c:v>HIGH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val>
            <c:numRef>
              <c:f>SNP_CALLING_DATA!$H$3:$H$50</c:f>
              <c:numCache>
                <c:formatCode>General</c:formatCode>
                <c:ptCount val="48"/>
                <c:pt idx="0">
                  <c:v>5018</c:v>
                </c:pt>
                <c:pt idx="1">
                  <c:v>5353</c:v>
                </c:pt>
                <c:pt idx="2">
                  <c:v>5731</c:v>
                </c:pt>
                <c:pt idx="3">
                  <c:v>4870</c:v>
                </c:pt>
                <c:pt idx="4">
                  <c:v>5140</c:v>
                </c:pt>
                <c:pt idx="5">
                  <c:v>5302</c:v>
                </c:pt>
                <c:pt idx="6">
                  <c:v>5195</c:v>
                </c:pt>
                <c:pt idx="7">
                  <c:v>5775</c:v>
                </c:pt>
                <c:pt idx="8">
                  <c:v>6114</c:v>
                </c:pt>
                <c:pt idx="9">
                  <c:v>5582</c:v>
                </c:pt>
                <c:pt idx="10">
                  <c:v>4917</c:v>
                </c:pt>
                <c:pt idx="11">
                  <c:v>5834</c:v>
                </c:pt>
                <c:pt idx="12">
                  <c:v>5166</c:v>
                </c:pt>
                <c:pt idx="13">
                  <c:v>5568</c:v>
                </c:pt>
                <c:pt idx="14">
                  <c:v>6065</c:v>
                </c:pt>
                <c:pt idx="15">
                  <c:v>5851</c:v>
                </c:pt>
                <c:pt idx="16">
                  <c:v>4962</c:v>
                </c:pt>
                <c:pt idx="17">
                  <c:v>5825</c:v>
                </c:pt>
                <c:pt idx="18">
                  <c:v>6372</c:v>
                </c:pt>
                <c:pt idx="19">
                  <c:v>4849</c:v>
                </c:pt>
                <c:pt idx="20">
                  <c:v>4357</c:v>
                </c:pt>
                <c:pt idx="21">
                  <c:v>5284</c:v>
                </c:pt>
                <c:pt idx="22">
                  <c:v>6224</c:v>
                </c:pt>
                <c:pt idx="23">
                  <c:v>5958</c:v>
                </c:pt>
                <c:pt idx="24">
                  <c:v>6536</c:v>
                </c:pt>
                <c:pt idx="25">
                  <c:v>6855</c:v>
                </c:pt>
                <c:pt idx="26">
                  <c:v>5589</c:v>
                </c:pt>
                <c:pt idx="27">
                  <c:v>6270</c:v>
                </c:pt>
                <c:pt idx="28">
                  <c:v>6045</c:v>
                </c:pt>
                <c:pt idx="29">
                  <c:v>5634</c:v>
                </c:pt>
                <c:pt idx="30">
                  <c:v>6608</c:v>
                </c:pt>
                <c:pt idx="31">
                  <c:v>5119</c:v>
                </c:pt>
                <c:pt idx="32">
                  <c:v>3860</c:v>
                </c:pt>
                <c:pt idx="33">
                  <c:v>3620</c:v>
                </c:pt>
                <c:pt idx="34">
                  <c:v>3794</c:v>
                </c:pt>
                <c:pt idx="35">
                  <c:v>3687</c:v>
                </c:pt>
                <c:pt idx="36">
                  <c:v>3805</c:v>
                </c:pt>
                <c:pt idx="37">
                  <c:v>3943</c:v>
                </c:pt>
                <c:pt idx="38">
                  <c:v>3795</c:v>
                </c:pt>
                <c:pt idx="39">
                  <c:v>2910</c:v>
                </c:pt>
                <c:pt idx="40">
                  <c:v>3775</c:v>
                </c:pt>
                <c:pt idx="41">
                  <c:v>3963</c:v>
                </c:pt>
                <c:pt idx="42">
                  <c:v>3886</c:v>
                </c:pt>
                <c:pt idx="43">
                  <c:v>3802</c:v>
                </c:pt>
                <c:pt idx="44">
                  <c:v>3776</c:v>
                </c:pt>
                <c:pt idx="45">
                  <c:v>3724</c:v>
                </c:pt>
                <c:pt idx="46">
                  <c:v>3718</c:v>
                </c:pt>
                <c:pt idx="47">
                  <c:v>38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235-5946-970B-C2AA61B9C2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"/>
        <c:overlap val="100"/>
        <c:axId val="1653497391"/>
        <c:axId val="1653172239"/>
      </c:barChart>
      <c:catAx>
        <c:axId val="165349739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ample ID</a:t>
                </a:r>
              </a:p>
            </c:rich>
          </c:tx>
          <c:layout>
            <c:manualLayout>
              <c:xMode val="edge"/>
              <c:yMode val="edge"/>
              <c:x val="0.49685362756228896"/>
              <c:y val="0.879876047090232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it-IT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1653172239"/>
        <c:crosses val="autoZero"/>
        <c:auto val="1"/>
        <c:lblAlgn val="ctr"/>
        <c:lblOffset val="100"/>
        <c:noMultiLvlLbl val="0"/>
      </c:catAx>
      <c:valAx>
        <c:axId val="16531722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noProof="0" dirty="0">
                    <a:latin typeface="Arial" panose="020B0604020202020204" pitchFamily="34" charset="0"/>
                    <a:cs typeface="Arial" panose="020B0604020202020204" pitchFamily="34" charset="0"/>
                  </a:rPr>
                  <a:t>Percentag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it-IT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65349739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7C4E7C0-D1ED-534F-A45A-C6614DB265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34C2949C-C73A-C546-9660-1FAF70F987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F926B13-3CE9-A942-A76B-170BFA23A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F17E-B588-5341-8D6F-DDEEFB3594A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BAA2302-EA9C-3B4D-BA25-D7F18C639B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F41DB7B-4BCD-4241-A36C-B98A49AB1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F3CC7-8E8E-F040-886F-A67B52216D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4011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D779B67-547D-6146-9302-825147E813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C1ED8C5-5584-A041-950A-810A46831A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3D26918-6B11-8642-BE16-9CCA3FE0E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F17E-B588-5341-8D6F-DDEEFB3594A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CFC479F-6827-0345-B3BF-7132A86F8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846E0C4-FF91-1D49-996E-06CFE0C1C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F3CC7-8E8E-F040-886F-A67B52216D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40085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15947CE2-CEEA-D44B-B7C0-8455CF856FB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C3F65DA-64B8-AC44-ABC6-96FE94C3DD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AECF6F5-AD60-0C41-AA7B-E65948FED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F17E-B588-5341-8D6F-DDEEFB3594A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AB8F34E-06BB-3149-922F-0DA40BDBC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0CE892C-EFAD-064C-BE97-98D51E486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F3CC7-8E8E-F040-886F-A67B52216D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0671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C80753B-E083-284C-AAA8-38EEE328C0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945CD04-ED53-4B4E-B820-EEFE2FF519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9BFA06C-0A06-E643-AA1C-1D92EA7AA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F17E-B588-5341-8D6F-DDEEFB3594A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F5BCB5B-00AF-C148-B5DE-2D27BE61B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6497168-F0ED-8C47-951F-AF9550915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F3CC7-8E8E-F040-886F-A67B52216D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29295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DFAB701-7DBC-1C4A-891A-C673F16606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B7C1E03-1AD8-7C4D-9B18-8C494D5C92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D25D6E2-8D3C-704E-AA36-12E6BBA36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F17E-B588-5341-8D6F-DDEEFB3594A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725C9B7-1793-DA4A-9BB3-943951A83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CC4DC99-C517-DC47-ADC2-AC6922301E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F3CC7-8E8E-F040-886F-A67B52216D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0011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D8304B7-C61C-8A45-A56D-F8FA5C03D4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6253006-3BFE-6A45-A18C-0682A5657C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ABE8E65-7D01-E043-A814-18F1DB2198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1E262EC-F4E4-2B40-B7F2-6C0DD6854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F17E-B588-5341-8D6F-DDEEFB3594A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56991F5-A2E7-7144-B81F-F58919D5E9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A2BFFFA-BF7D-F046-B079-78CEA90FD0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F3CC7-8E8E-F040-886F-A67B52216D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1090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8EF67B4-0B03-ED4F-A58B-385D9E226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8813A5F-D89D-214E-9225-8FD528D3F9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B6CD0E8-7840-B34B-929E-51DF756D54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B21AAC3B-B0CE-5344-BC05-3FE2CAAD41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1C694FEF-B91E-3442-849B-D6DC232A13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19772D6-317D-4D48-9816-15019F347D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F17E-B588-5341-8D6F-DDEEFB3594A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6ACB7E4-B8F1-9D48-ADFA-7BD4DE9429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0101952F-D480-CC41-A9A3-8DC896F4D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F3CC7-8E8E-F040-886F-A67B52216D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7936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809FAC5-7FA8-7241-8152-AA89E230A8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506AC364-6C54-2F4B-9EED-BCAE9257E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F17E-B588-5341-8D6F-DDEEFB3594A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F846118-88B3-7D41-90C4-1BCE12DF6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441EB2C4-F908-6046-93F0-6A31595A16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F3CC7-8E8E-F040-886F-A67B52216D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57404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8F8A421-8B2B-8944-93AB-AFC9269E92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F17E-B588-5341-8D6F-DDEEFB3594A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3B518621-F6FA-3846-86E4-FE4C822A40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FFE4A8A0-6064-0444-B4D7-220C962EB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F3CC7-8E8E-F040-886F-A67B52216D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5160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71F4D96-790B-4244-A0E4-02980EBCF0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D8940CB-4D07-E345-A313-1FCBFAD8F7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60FFA8B-2FF4-5346-8C8B-6D71DE3F2B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4F9924F-EF1F-9143-9D46-C765A44D11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F17E-B588-5341-8D6F-DDEEFB3594A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A074E1B-EFBC-144F-96D2-3C43DEF5F1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366FA3D-43DB-0A4E-A9AA-7D8E25C14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F3CC7-8E8E-F040-886F-A67B52216D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0672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CDD7B71-AA73-F34F-9347-A4E540FBCE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35D4EC6-E576-0C42-B24B-804B80099F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6FA0C4B-32C5-7949-89DB-729B897B55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010802D-8549-A743-BC71-656EF30C0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FF17E-B588-5341-8D6F-DDEEFB3594A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0E09F38-2B19-FE49-B597-8BA5C80EE4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A8656CC-037A-1A4D-AF96-32F89689A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F3CC7-8E8E-F040-886F-A67B52216D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9007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2A3A825A-3535-7D4C-8CC5-385D27DCC0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D09ACF1-C2A6-194B-B7FE-C7254377C4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02E4303-2285-294D-821D-F66B32F663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FF17E-B588-5341-8D6F-DDEEFB3594A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EDDBC5A-32D9-C540-8886-4B444E2D05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4915615-E367-5D4D-A246-93381E1781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7F3CC7-8E8E-F040-886F-A67B52216D2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8891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28254ADD-B3FB-2846-9327-5760A475F9A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126160"/>
              </p:ext>
            </p:extLst>
          </p:nvPr>
        </p:nvGraphicFramePr>
        <p:xfrm>
          <a:off x="411480" y="592753"/>
          <a:ext cx="11441430" cy="52108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CasellaDiTesto 4">
            <a:extLst>
              <a:ext uri="{FF2B5EF4-FFF2-40B4-BE49-F238E27FC236}">
                <a16:creationId xmlns:a16="http://schemas.microsoft.com/office/drawing/2014/main" id="{563122D6-E8B2-11CE-8260-52251716E587}"/>
              </a:ext>
            </a:extLst>
          </p:cNvPr>
          <p:cNvSpPr txBox="1"/>
          <p:nvPr/>
        </p:nvSpPr>
        <p:spPr>
          <a:xfrm>
            <a:off x="0" y="5811559"/>
            <a:ext cx="100533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4.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00% Stacked bar chart showing the percentage of SNPs grouped by their impact (low, moderate and high) for each individual.</a:t>
            </a:r>
            <a:endParaRPr lang="it-IT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124483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66</TotalTime>
  <Words>32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lvatore esposito</dc:creator>
  <cp:lastModifiedBy>Salvatore Esposito</cp:lastModifiedBy>
  <cp:revision>14</cp:revision>
  <dcterms:created xsi:type="dcterms:W3CDTF">2022-02-21T09:14:58Z</dcterms:created>
  <dcterms:modified xsi:type="dcterms:W3CDTF">2022-11-04T13:44:52Z</dcterms:modified>
</cp:coreProperties>
</file>